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8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bie Stark (Aneurin Bevan UHB - Learning Disabilities)" userId="dba745bf-c3eb-4042-85bc-0d2b69f16cc5" providerId="ADAL" clId="{D7467E89-08BD-42B8-9EA3-983CEC5FD02E}"/>
    <pc:docChg chg="delSld">
      <pc:chgData name="Abbie Stark (Aneurin Bevan UHB - Learning Disabilities)" userId="dba745bf-c3eb-4042-85bc-0d2b69f16cc5" providerId="ADAL" clId="{D7467E89-08BD-42B8-9EA3-983CEC5FD02E}" dt="2025-04-16T10:03:05.276" v="1" actId="2696"/>
      <pc:docMkLst>
        <pc:docMk/>
      </pc:docMkLst>
      <pc:sldChg chg="del">
        <pc:chgData name="Abbie Stark (Aneurin Bevan UHB - Learning Disabilities)" userId="dba745bf-c3eb-4042-85bc-0d2b69f16cc5" providerId="ADAL" clId="{D7467E89-08BD-42B8-9EA3-983CEC5FD02E}" dt="2025-04-16T10:03:02.891" v="0" actId="2696"/>
        <pc:sldMkLst>
          <pc:docMk/>
          <pc:sldMk cId="1314528433" sldId="256"/>
        </pc:sldMkLst>
      </pc:sldChg>
      <pc:sldChg chg="del">
        <pc:chgData name="Abbie Stark (Aneurin Bevan UHB - Learning Disabilities)" userId="dba745bf-c3eb-4042-85bc-0d2b69f16cc5" providerId="ADAL" clId="{D7467E89-08BD-42B8-9EA3-983CEC5FD02E}" dt="2025-04-16T10:03:05.276" v="1" actId="2696"/>
        <pc:sldMkLst>
          <pc:docMk/>
          <pc:sldMk cId="1484664869" sldId="257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https://nhswales365-my.sharepoint.com/personal/abbie_s_stark_wales_nhs_uk/Documents/Clinical%20Psychologist%20-%20LD%20role/Publication/PH%20Study%20Revisions/Newest%20Revision%20Documents/Means%20and%20SDs%20completer%20and%20ITT/GAD%20graph%20and%20clinical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Mean</a:t>
            </a:r>
            <a:r>
              <a:rPr lang="en-GB" baseline="0"/>
              <a:t> anxiety scores for the CBT and control group across time</a:t>
            </a:r>
            <a:endParaRPr lang="en-GB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GB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[GAD graph and clinical change ITT and Completer.xlsx]Sheet1'!$A$3</c:f>
              <c:strCache>
                <c:ptCount val="1"/>
                <c:pt idx="0">
                  <c:v>CBT group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[GAD graph and clinical change ITT and Completer.xlsx]Sheet1'!$B$2:$D$2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GAD graph and clinical change ITT and Completer.xlsx]Sheet1'!$B$3:$D$3</c:f>
              <c:numCache>
                <c:formatCode>General</c:formatCode>
                <c:ptCount val="3"/>
                <c:pt idx="0">
                  <c:v>10.1</c:v>
                </c:pt>
                <c:pt idx="1">
                  <c:v>7.52</c:v>
                </c:pt>
                <c:pt idx="2">
                  <c:v>6.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F65-4CF7-AEB0-3FE52C6CB99A}"/>
            </c:ext>
          </c:extLst>
        </c:ser>
        <c:ser>
          <c:idx val="1"/>
          <c:order val="1"/>
          <c:tx>
            <c:strRef>
              <c:f>'[GAD graph and clinical change ITT and Completer.xlsx]Sheet1'!$A$4</c:f>
              <c:strCache>
                <c:ptCount val="1"/>
                <c:pt idx="0">
                  <c:v>Control group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[GAD graph and clinical change ITT and Completer.xlsx]Sheet1'!$B$2:$D$2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GAD graph and clinical change ITT and Completer.xlsx]Sheet1'!$B$4:$D$4</c:f>
              <c:numCache>
                <c:formatCode>General</c:formatCode>
                <c:ptCount val="3"/>
                <c:pt idx="0">
                  <c:v>11.3</c:v>
                </c:pt>
                <c:pt idx="1">
                  <c:v>10.52</c:v>
                </c:pt>
                <c:pt idx="2">
                  <c:v>9.21000000000000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F65-4CF7-AEB0-3FE52C6CB99A}"/>
            </c:ext>
          </c:extLst>
        </c:ser>
        <c:ser>
          <c:idx val="2"/>
          <c:order val="2"/>
          <c:tx>
            <c:strRef>
              <c:f>'[GAD graph and clinical change ITT and Completer.xlsx]Sheet1'!$A$5</c:f>
              <c:strCache>
                <c:ptCount val="1"/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[GAD graph and clinical change ITT and Completer.xlsx]Sheet1'!$B$2:$D$2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GAD graph and clinical change ITT and Completer.xlsx]Sheet1'!$B$5:$D$5</c:f>
              <c:numCache>
                <c:formatCode>General</c:formatCode>
                <c:ptCount val="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F65-4CF7-AEB0-3FE52C6CB99A}"/>
            </c:ext>
          </c:extLst>
        </c:ser>
        <c:ser>
          <c:idx val="3"/>
          <c:order val="3"/>
          <c:tx>
            <c:strRef>
              <c:f>'[GAD graph and clinical change ITT and Completer.xlsx]Sheet1'!$A$6</c:f>
              <c:strCache>
                <c:ptCount val="1"/>
                <c:pt idx="0">
                  <c:v>CBT group ITT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[GAD graph and clinical change ITT and Completer.xlsx]Sheet1'!$B$2:$D$2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GAD graph and clinical change ITT and Completer.xlsx]Sheet1'!$B$6:$D$6</c:f>
              <c:numCache>
                <c:formatCode>General</c:formatCode>
                <c:ptCount val="3"/>
                <c:pt idx="0">
                  <c:v>9.36</c:v>
                </c:pt>
                <c:pt idx="1">
                  <c:v>6.76</c:v>
                </c:pt>
                <c:pt idx="2">
                  <c:v>5.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F65-4CF7-AEB0-3FE52C6CB99A}"/>
            </c:ext>
          </c:extLst>
        </c:ser>
        <c:ser>
          <c:idx val="4"/>
          <c:order val="4"/>
          <c:tx>
            <c:strRef>
              <c:f>'[GAD graph and clinical change ITT and Completer.xlsx]Sheet1'!$A$7</c:f>
              <c:strCache>
                <c:ptCount val="1"/>
                <c:pt idx="0">
                  <c:v>Control group ITT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[GAD graph and clinical change ITT and Completer.xlsx]Sheet1'!$B$2:$D$2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GAD graph and clinical change ITT and Completer.xlsx]Sheet1'!$B$7:$D$7</c:f>
              <c:numCache>
                <c:formatCode>General</c:formatCode>
                <c:ptCount val="3"/>
                <c:pt idx="0">
                  <c:v>11.11</c:v>
                </c:pt>
                <c:pt idx="1">
                  <c:v>10.34</c:v>
                </c:pt>
                <c:pt idx="2">
                  <c:v>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F65-4CF7-AEB0-3FE52C6CB9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88172512"/>
        <c:axId val="388169152"/>
      </c:lineChart>
      <c:catAx>
        <c:axId val="388172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8169152"/>
        <c:crosses val="autoZero"/>
        <c:auto val="1"/>
        <c:lblAlgn val="ctr"/>
        <c:lblOffset val="100"/>
        <c:noMultiLvlLbl val="0"/>
      </c:catAx>
      <c:valAx>
        <c:axId val="388169152"/>
        <c:scaling>
          <c:orientation val="minMax"/>
          <c:max val="16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81725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56C284-CA09-CD4B-5C55-E26867CE76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660013-A281-E875-89EA-FCFC54123C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39A591-615B-9146-E3D9-740B8E3E6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3AA8A6-8A0A-F13B-0B65-B7414369E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FEA92B-2F42-ED4E-5E6B-091923CAD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6233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B0DE80-2599-D9CB-B5C2-8FA71AC110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74C3FD-0C33-F55E-303B-9075C2A875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33C735-C035-028D-A668-D1F4FB2D4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2CDAE9-DD40-2BFE-5673-02F446346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33C655-5B46-7622-A89E-553CFB850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5792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E530F1C-F5C3-3044-13A5-8637BB2F79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F9DC6D-95FB-2339-E675-D1F70EC35A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3D447F-FAD9-4921-1334-BB5B80B92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EC7790-44FD-EF70-3A13-9471EED562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41560A-8AB3-7B3F-9A44-971DA196B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200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184DCB-4C3D-59F7-F0B7-7C53D59DBA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09114F-FFB1-04B1-D879-A2EB2BFBB3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12B8E4-EF5F-49F2-430E-CF45B7A3A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77A280-8360-0B29-F400-FFD4071B9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79184A-8A21-14C6-8AC6-7337BCCA36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2948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6AC9DF-77D7-7B50-B1EC-43BA21EC8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3AECE2-4A18-33CD-6DE7-2840399157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060D9F-5E21-DBA6-C314-0E9745C6E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BA674-A32C-243A-2A59-B726375D6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6865DD-8803-B7A1-ECF3-D50C4FC9E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107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4CE48D-74D1-C9C6-1463-73616A1317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64F5BD-AD9B-81D0-0E76-09E664A984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8F8D4B-E0D6-2B3A-73FB-DF2418B74B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A6A690-D12B-090B-0F52-38EBE3F172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F36037-2CCE-69EB-6D2F-86B1A3A9C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80DD25-92D6-F7E8-40E3-B7B718367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8285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A1F70-84A0-44D4-47CC-73D2C7AA55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A301E9-8932-9B45-D9FF-C5229C9E6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490604-613F-771F-FE30-D4F5EBC7B8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78AC5B3-1E64-4A0F-EAD4-317CE10C28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4B6A16B-7699-23F0-F7FF-3C0E4AB831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1214EB-F708-778B-D0D3-BFDA9E4C9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1C642A3-2791-55C3-4AD9-029D3A5CC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D9C25A1-D372-107F-0089-FB563D5CA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89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108D01-E1A3-6149-B13E-AEC7EA1B98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58FA28-7362-6222-425B-29756E60D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0D4037-171D-39EE-A55C-C5BF8FEF4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8813F7-1E5C-CCEA-5FDE-06D00A068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3119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6C2914-9543-76AA-8BC3-60DD1E79E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D15C72-B193-C256-A1EB-D1FE3608B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1ECBFC-C663-C4C9-ACD5-BE97F7A26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2695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DC6CE4-45DA-27AF-D482-E8C63DF7AF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923FEE-E2F8-33CF-9624-37564C790F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A25CCB-25CB-403D-B10E-893825390B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D09FFE-F1D3-07CC-7883-AADBC4A34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41A16D-2180-9219-1310-408E998B0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6303DC-75E0-C283-CAA6-BA09CE047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3393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1A285B-38AF-607B-0BFD-8161473F7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638A35-5DA5-1C5E-8073-24765098B7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ED4C11-7D8B-95C0-D60E-F3CD62AD1E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762F3D-2903-5BC0-F29B-647F7EB6C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0A4B05-77F9-86AF-8A9C-1858E165E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ED7F9C-C07C-6DF4-F1AB-3189AAE3F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1514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A14A67-B98D-3EA6-7A92-2EB464D4F0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D20B8B-EA6C-3E3F-B310-6802B7C702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2537F5-57E8-11C1-C81A-FC50B9498D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4D1388-13FC-4F19-86EE-0B348D9EEAE9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1FCFB-AC0D-533D-746A-4BA22B62B2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42D4CA-9F4B-C584-2FE4-CA4432BD78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ABA88B-98BF-45DC-9065-846C2E7F6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7335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6A8F1948-49E4-4092-9350-E4E8104D0E4D}"/>
              </a:ext>
            </a:extLst>
          </p:cNvPr>
          <p:cNvSpPr txBox="1"/>
          <p:nvPr/>
        </p:nvSpPr>
        <p:spPr>
          <a:xfrm>
            <a:off x="3674280" y="3799643"/>
            <a:ext cx="4866037" cy="51470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B81251E-8D89-432F-9F12-C8AFCFF55E1F}"/>
              </a:ext>
            </a:extLst>
          </p:cNvPr>
          <p:cNvSpPr txBox="1"/>
          <p:nvPr/>
        </p:nvSpPr>
        <p:spPr>
          <a:xfrm>
            <a:off x="3674280" y="3429000"/>
            <a:ext cx="4866037" cy="370643"/>
          </a:xfrm>
          <a:prstGeom prst="rect">
            <a:avLst/>
          </a:prstGeom>
          <a:solidFill>
            <a:schemeClr val="tx2">
              <a:lumMod val="10000"/>
              <a:lumOff val="90000"/>
            </a:schemeClr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F8666CB-C9CC-4BD9-9E7D-5D4A640E8BB0}"/>
              </a:ext>
            </a:extLst>
          </p:cNvPr>
          <p:cNvSpPr txBox="1"/>
          <p:nvPr/>
        </p:nvSpPr>
        <p:spPr>
          <a:xfrm>
            <a:off x="3674280" y="2858610"/>
            <a:ext cx="4866037" cy="57039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A7F2A653-229B-0D54-4DDB-559043FB76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1020076"/>
              </p:ext>
            </p:extLst>
          </p:nvPr>
        </p:nvGraphicFramePr>
        <p:xfrm>
          <a:off x="3382392" y="2071687"/>
          <a:ext cx="5266308" cy="2802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F67F6D5-9C87-44DC-940B-55CD96A31B79}"/>
              </a:ext>
            </a:extLst>
          </p:cNvPr>
          <p:cNvSpPr txBox="1"/>
          <p:nvPr/>
        </p:nvSpPr>
        <p:spPr>
          <a:xfrm>
            <a:off x="3674280" y="2698853"/>
            <a:ext cx="1828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Severe anxiety</a:t>
            </a:r>
            <a:endParaRPr lang="en-GB" sz="8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5FF59AB-7104-4640-87E6-BAA679339C4C}"/>
              </a:ext>
            </a:extLst>
          </p:cNvPr>
          <p:cNvSpPr txBox="1"/>
          <p:nvPr/>
        </p:nvSpPr>
        <p:spPr>
          <a:xfrm>
            <a:off x="3674280" y="2754541"/>
            <a:ext cx="4866037" cy="104069"/>
          </a:xfrm>
          <a:prstGeom prst="rect">
            <a:avLst/>
          </a:prstGeom>
          <a:solidFill>
            <a:srgbClr val="FF0000">
              <a:alpha val="33000"/>
            </a:srgbClr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A266D3D-AF58-4B07-93C7-D7DB24960685}"/>
              </a:ext>
            </a:extLst>
          </p:cNvPr>
          <p:cNvSpPr txBox="1"/>
          <p:nvPr/>
        </p:nvSpPr>
        <p:spPr>
          <a:xfrm>
            <a:off x="3674280" y="2956204"/>
            <a:ext cx="1828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Moderate anxiety</a:t>
            </a:r>
            <a:endParaRPr lang="en-GB" sz="8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43D63CF-B0BC-4667-8051-8DF843C44161}"/>
              </a:ext>
            </a:extLst>
          </p:cNvPr>
          <p:cNvSpPr txBox="1"/>
          <p:nvPr/>
        </p:nvSpPr>
        <p:spPr>
          <a:xfrm>
            <a:off x="3674280" y="3526594"/>
            <a:ext cx="1828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Mild anxiety</a:t>
            </a:r>
            <a:endParaRPr lang="en-GB" sz="8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00DCC88-EDA2-4B3F-8E3E-DDE28570FC88}"/>
              </a:ext>
            </a:extLst>
          </p:cNvPr>
          <p:cNvSpPr txBox="1"/>
          <p:nvPr/>
        </p:nvSpPr>
        <p:spPr>
          <a:xfrm>
            <a:off x="3674280" y="3914063"/>
            <a:ext cx="1828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Minimal anxiety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18748272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 Narrow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1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ie Stark</dc:creator>
  <cp:lastModifiedBy>Abbie Stark (Aneurin Bevan UHB - Learning Disabilities)</cp:lastModifiedBy>
  <cp:revision>5</cp:revision>
  <dcterms:created xsi:type="dcterms:W3CDTF">2024-04-08T13:48:58Z</dcterms:created>
  <dcterms:modified xsi:type="dcterms:W3CDTF">2025-04-16T10:03:09Z</dcterms:modified>
</cp:coreProperties>
</file>